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304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80000"/>
    <a:srgbClr val="1802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57" d="100"/>
          <a:sy n="57" d="100"/>
        </p:scale>
        <p:origin x="3534" y="108"/>
      </p:cViewPr>
      <p:guideLst>
        <p:guide orient="horz" pos="3840"/>
        <p:guide pos="30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E5B021-46F3-4400-9DC4-8D5F526D4AF8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CE5774-BE42-4F69-96C2-1F4A390B37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819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CE5774-BE42-4F69-96C2-1F4A390B374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2824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454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8515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5902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4599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176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6252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6133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033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5681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46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9C8251-B31F-450C-8E33-D345FF4E13ED}" type="datetimeFigureOut">
              <a:rPr lang="en-GB" smtClean="0"/>
              <a:t>06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64628E-3C2B-4278-A3B4-CA632DB222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7154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>
            <a:extLst>
              <a:ext uri="{FF2B5EF4-FFF2-40B4-BE49-F238E27FC236}">
                <a16:creationId xmlns:a16="http://schemas.microsoft.com/office/drawing/2014/main" id="{6BB4A6EA-8ED8-CF3C-4493-DC97AF032F33}"/>
              </a:ext>
            </a:extLst>
          </p:cNvPr>
          <p:cNvGrpSpPr/>
          <p:nvPr/>
        </p:nvGrpSpPr>
        <p:grpSpPr>
          <a:xfrm>
            <a:off x="1036307" y="342900"/>
            <a:ext cx="4805044" cy="9391650"/>
            <a:chOff x="1036307" y="342900"/>
            <a:chExt cx="4805044" cy="9391650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CB7A062E-89D4-A5D4-54C4-FACECFF55EE0}"/>
                </a:ext>
              </a:extLst>
            </p:cNvPr>
            <p:cNvGrpSpPr/>
            <p:nvPr/>
          </p:nvGrpSpPr>
          <p:grpSpPr>
            <a:xfrm>
              <a:off x="1036307" y="342900"/>
              <a:ext cx="3717726" cy="3124200"/>
              <a:chOff x="1425773" y="342900"/>
              <a:chExt cx="3717726" cy="3124200"/>
            </a:xfrm>
          </p:grpSpPr>
          <p:pic>
            <p:nvPicPr>
              <p:cNvPr id="4" name="Content Placeholder 4" descr="A graph of different colored and black lines&#10;&#10;Description automatically generated">
                <a:extLst>
                  <a:ext uri="{FF2B5EF4-FFF2-40B4-BE49-F238E27FC236}">
                    <a16:creationId xmlns:a16="http://schemas.microsoft.com/office/drawing/2014/main" id="{8B798ED4-22B1-21B6-9B68-1755646EE3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1962" t="551" r="65405" b="47501"/>
              <a:stretch>
                <a:fillRect/>
              </a:stretch>
            </p:blipFill>
            <p:spPr>
              <a:xfrm>
                <a:off x="1733550" y="342900"/>
                <a:ext cx="3409949" cy="3124200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3BDDC08-24DC-E2CB-BC0C-C8EB0A043478}"/>
                  </a:ext>
                </a:extLst>
              </p:cNvPr>
              <p:cNvSpPr txBox="1"/>
              <p:nvPr/>
            </p:nvSpPr>
            <p:spPr>
              <a:xfrm rot="16200000">
                <a:off x="922437" y="1855887"/>
                <a:ext cx="13144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ea typeface="Calibri" panose="020F0502020204030204" pitchFamily="34" charset="0"/>
                    <a:cs typeface="Calibri" panose="020F0502020204030204" pitchFamily="34" charset="0"/>
                  </a:rPr>
                  <a:t>read count</a:t>
                </a:r>
                <a:endParaRPr lang="en-GB" sz="1400" dirty="0"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A2995002-6987-27A4-5ECF-2C573C6D4645}"/>
                  </a:ext>
                </a:extLst>
              </p:cNvPr>
              <p:cNvSpPr/>
              <p:nvPr/>
            </p:nvSpPr>
            <p:spPr>
              <a:xfrm>
                <a:off x="1724025" y="1123950"/>
                <a:ext cx="45719" cy="88582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BB7B63B5-8B62-E928-EB31-7A52219AE7B3}"/>
                  </a:ext>
                </a:extLst>
              </p:cNvPr>
              <p:cNvSpPr txBox="1"/>
              <p:nvPr/>
            </p:nvSpPr>
            <p:spPr>
              <a:xfrm>
                <a:off x="3071691" y="449818"/>
                <a:ext cx="108585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/>
                  <a:t>no inulin</a:t>
                </a:r>
                <a:endParaRPr lang="en-GB" b="1" dirty="0"/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DA7A6E40-7FCD-68FD-772B-7ED2B1E72389}"/>
                </a:ext>
              </a:extLst>
            </p:cNvPr>
            <p:cNvGrpSpPr/>
            <p:nvPr/>
          </p:nvGrpSpPr>
          <p:grpSpPr>
            <a:xfrm>
              <a:off x="1072500" y="3571875"/>
              <a:ext cx="3686157" cy="3124201"/>
              <a:chOff x="1461966" y="3571875"/>
              <a:chExt cx="3686157" cy="3124201"/>
            </a:xfrm>
          </p:grpSpPr>
          <p:pic>
            <p:nvPicPr>
              <p:cNvPr id="5" name="Picture 4" descr="A graph of a graph showing the number of numbers&#10;&#10;Description automatically generated with medium confidence">
                <a:extLst>
                  <a:ext uri="{FF2B5EF4-FFF2-40B4-BE49-F238E27FC236}">
                    <a16:creationId xmlns:a16="http://schemas.microsoft.com/office/drawing/2014/main" id="{DA4A1C35-1503-821F-C3DA-6169A69474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2231" t="1260" r="65947" b="48027"/>
              <a:stretch>
                <a:fillRect/>
              </a:stretch>
            </p:blipFill>
            <p:spPr>
              <a:xfrm>
                <a:off x="1762125" y="3571875"/>
                <a:ext cx="3385998" cy="3124201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B431BDC-32EA-F9F3-AB2C-D1D04455FEF2}"/>
                  </a:ext>
                </a:extLst>
              </p:cNvPr>
              <p:cNvSpPr txBox="1"/>
              <p:nvPr/>
            </p:nvSpPr>
            <p:spPr>
              <a:xfrm rot="16200000">
                <a:off x="958630" y="5056287"/>
                <a:ext cx="13144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ea typeface="Calibri" panose="020F0502020204030204" pitchFamily="34" charset="0"/>
                    <a:cs typeface="Calibri" panose="020F0502020204030204" pitchFamily="34" charset="0"/>
                  </a:rPr>
                  <a:t>read count</a:t>
                </a:r>
                <a:endParaRPr lang="en-GB" sz="1400" dirty="0"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6EFFBAF-53ED-20B3-2825-82B3173FF51A}"/>
                  </a:ext>
                </a:extLst>
              </p:cNvPr>
              <p:cNvSpPr txBox="1"/>
              <p:nvPr/>
            </p:nvSpPr>
            <p:spPr>
              <a:xfrm>
                <a:off x="3071691" y="3716893"/>
                <a:ext cx="108585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/>
                  <a:t>+ inulin</a:t>
                </a:r>
                <a:endParaRPr lang="en-GB" b="1" dirty="0"/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07C8EEA1-D483-6036-B0F1-EA7D99B697CD}"/>
                </a:ext>
              </a:extLst>
            </p:cNvPr>
            <p:cNvGrpSpPr/>
            <p:nvPr/>
          </p:nvGrpSpPr>
          <p:grpSpPr>
            <a:xfrm>
              <a:off x="2914931" y="6257925"/>
              <a:ext cx="2683921" cy="3476625"/>
              <a:chOff x="3304397" y="6257925"/>
              <a:chExt cx="2683921" cy="3476625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5313B57-85BD-5D46-CCC7-0C956C3232BD}"/>
                  </a:ext>
                </a:extLst>
              </p:cNvPr>
              <p:cNvSpPr txBox="1"/>
              <p:nvPr/>
            </p:nvSpPr>
            <p:spPr>
              <a:xfrm rot="2975074">
                <a:off x="1737922" y="7824400"/>
                <a:ext cx="34099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phosphate acetyltransferase (EC 2.3.1.8)</a:t>
                </a:r>
                <a:endParaRPr lang="en-GB" sz="1200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9409A27-A478-AD0E-DEAD-916468DD7677}"/>
                  </a:ext>
                </a:extLst>
              </p:cNvPr>
              <p:cNvSpPr txBox="1"/>
              <p:nvPr/>
            </p:nvSpPr>
            <p:spPr>
              <a:xfrm rot="2975074">
                <a:off x="2334890" y="7824400"/>
                <a:ext cx="34099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acetate kinase (EC 2.7.2.1)</a:t>
                </a:r>
                <a:endParaRPr lang="en-GB" sz="1200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6928423-B516-0305-FC2D-58703A977234}"/>
                  </a:ext>
                </a:extLst>
              </p:cNvPr>
              <p:cNvSpPr txBox="1"/>
              <p:nvPr/>
            </p:nvSpPr>
            <p:spPr>
              <a:xfrm rot="2975074">
                <a:off x="2917570" y="7857738"/>
                <a:ext cx="3476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short-chain acyl-CoA dehydrogenase (EC 1.3.8.1)</a:t>
                </a:r>
                <a:endParaRPr lang="en-GB" sz="1200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474A2ED-BD6A-812B-B36A-BAD1313A3F58}"/>
                  </a:ext>
                </a:extLst>
              </p:cNvPr>
              <p:cNvSpPr txBox="1"/>
              <p:nvPr/>
            </p:nvSpPr>
            <p:spPr>
              <a:xfrm rot="2975074">
                <a:off x="3633601" y="7824401"/>
                <a:ext cx="34099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acetate-CoA ligase (ADP-forming) (EC 6.2.1.13)</a:t>
                </a:r>
                <a:endParaRPr lang="en-GB" sz="1200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7E8BD44-79A0-B9B8-2E77-6502DF4F7F14}"/>
                  </a:ext>
                </a:extLst>
              </p:cNvPr>
              <p:cNvSpPr txBox="1"/>
              <p:nvPr/>
            </p:nvSpPr>
            <p:spPr>
              <a:xfrm rot="2975074">
                <a:off x="4144844" y="7824401"/>
                <a:ext cx="34099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acetyl-CoA synthetase (EC 6.2.1.1)</a:t>
                </a:r>
                <a:endParaRPr lang="en-GB" sz="1200" dirty="0"/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44F6F6F7-00B4-E7DE-2FDB-E70AD75ABFF9}"/>
                </a:ext>
              </a:extLst>
            </p:cNvPr>
            <p:cNvGrpSpPr/>
            <p:nvPr/>
          </p:nvGrpSpPr>
          <p:grpSpPr>
            <a:xfrm>
              <a:off x="4949109" y="1266437"/>
              <a:ext cx="892242" cy="589175"/>
              <a:chOff x="5338575" y="1266437"/>
              <a:chExt cx="892242" cy="589175"/>
            </a:xfrm>
          </p:grpSpPr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7334DAAC-37D4-A999-20B6-96A75CC5D66C}"/>
                  </a:ext>
                </a:extLst>
              </p:cNvPr>
              <p:cNvSpPr/>
              <p:nvPr/>
            </p:nvSpPr>
            <p:spPr>
              <a:xfrm>
                <a:off x="5338575" y="1352550"/>
                <a:ext cx="93652" cy="104775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30C99E02-8B0E-C50E-BE77-793318117EB5}"/>
                  </a:ext>
                </a:extLst>
              </p:cNvPr>
              <p:cNvSpPr/>
              <p:nvPr/>
            </p:nvSpPr>
            <p:spPr>
              <a:xfrm>
                <a:off x="5338575" y="1662112"/>
                <a:ext cx="93652" cy="104775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7B667B14-421A-6448-35BD-15EC7C57ACFA}"/>
                  </a:ext>
                </a:extLst>
              </p:cNvPr>
              <p:cNvSpPr/>
              <p:nvPr/>
            </p:nvSpPr>
            <p:spPr>
              <a:xfrm>
                <a:off x="5338575" y="1507331"/>
                <a:ext cx="93652" cy="104775"/>
              </a:xfrm>
              <a:prstGeom prst="rect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429FFF14-D4AA-4002-6568-6C3CCF75D266}"/>
                  </a:ext>
                </a:extLst>
              </p:cNvPr>
              <p:cNvSpPr txBox="1"/>
              <p:nvPr/>
            </p:nvSpPr>
            <p:spPr>
              <a:xfrm>
                <a:off x="5385401" y="1266437"/>
                <a:ext cx="7772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baseline</a:t>
                </a:r>
                <a:endParaRPr lang="en-GB" sz="1200" dirty="0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832AFF6-ED34-12AF-9576-FEE4AF613F38}"/>
                  </a:ext>
                </a:extLst>
              </p:cNvPr>
              <p:cNvSpPr txBox="1"/>
              <p:nvPr/>
            </p:nvSpPr>
            <p:spPr>
              <a:xfrm>
                <a:off x="5364063" y="1422525"/>
                <a:ext cx="8667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no O3FAs</a:t>
                </a:r>
                <a:endParaRPr lang="en-GB" sz="1200" dirty="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2C1C14B-06CD-5CA2-8E44-DDE36ED400B1}"/>
                  </a:ext>
                </a:extLst>
              </p:cNvPr>
              <p:cNvSpPr txBox="1"/>
              <p:nvPr/>
            </p:nvSpPr>
            <p:spPr>
              <a:xfrm>
                <a:off x="5385401" y="1578613"/>
                <a:ext cx="7772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+ O3FAs</a:t>
                </a:r>
                <a:endParaRPr lang="en-GB" sz="1200" dirty="0"/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E40ABDC5-5B11-64E6-A554-D9FAF11B7C9E}"/>
                </a:ext>
              </a:extLst>
            </p:cNvPr>
            <p:cNvGrpSpPr/>
            <p:nvPr/>
          </p:nvGrpSpPr>
          <p:grpSpPr>
            <a:xfrm>
              <a:off x="4949109" y="4462230"/>
              <a:ext cx="892242" cy="589175"/>
              <a:chOff x="5338575" y="4462230"/>
              <a:chExt cx="892242" cy="589175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7036A09A-5934-F51A-5D11-D97687A98C71}"/>
                  </a:ext>
                </a:extLst>
              </p:cNvPr>
              <p:cNvSpPr/>
              <p:nvPr/>
            </p:nvSpPr>
            <p:spPr>
              <a:xfrm>
                <a:off x="5338575" y="4552950"/>
                <a:ext cx="93652" cy="104775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A789A575-E521-51B4-9C6B-0857600BFF7F}"/>
                  </a:ext>
                </a:extLst>
              </p:cNvPr>
              <p:cNvSpPr/>
              <p:nvPr/>
            </p:nvSpPr>
            <p:spPr>
              <a:xfrm>
                <a:off x="5338575" y="4862512"/>
                <a:ext cx="93652" cy="104775"/>
              </a:xfrm>
              <a:prstGeom prst="rect">
                <a:avLst/>
              </a:prstGeom>
              <a:solidFill>
                <a:srgbClr val="C80000"/>
              </a:solidFill>
              <a:ln>
                <a:solidFill>
                  <a:srgbClr val="C8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41ADA1B2-EFD5-6AB7-5E4A-C91AA4FE5072}"/>
                  </a:ext>
                </a:extLst>
              </p:cNvPr>
              <p:cNvSpPr/>
              <p:nvPr/>
            </p:nvSpPr>
            <p:spPr>
              <a:xfrm>
                <a:off x="5338575" y="4707731"/>
                <a:ext cx="93652" cy="104775"/>
              </a:xfrm>
              <a:prstGeom prst="rect">
                <a:avLst/>
              </a:prstGeom>
              <a:solidFill>
                <a:srgbClr val="1802BE"/>
              </a:solidFill>
              <a:ln>
                <a:solidFill>
                  <a:srgbClr val="1802BE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55BAF326-5CE2-221A-B897-BEBCBDE087E4}"/>
                  </a:ext>
                </a:extLst>
              </p:cNvPr>
              <p:cNvSpPr txBox="1"/>
              <p:nvPr/>
            </p:nvSpPr>
            <p:spPr>
              <a:xfrm>
                <a:off x="5385401" y="4462230"/>
                <a:ext cx="7772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baseline</a:t>
                </a:r>
                <a:endParaRPr lang="en-GB" sz="12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A86E3F7D-CFEC-9702-35A4-106239CBFFA2}"/>
                  </a:ext>
                </a:extLst>
              </p:cNvPr>
              <p:cNvSpPr txBox="1"/>
              <p:nvPr/>
            </p:nvSpPr>
            <p:spPr>
              <a:xfrm>
                <a:off x="5364063" y="4618318"/>
                <a:ext cx="8667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no O3FAs</a:t>
                </a:r>
                <a:endParaRPr lang="en-GB" sz="12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2ECF09B-3148-AFF3-8496-22030C0AEF35}"/>
                  </a:ext>
                </a:extLst>
              </p:cNvPr>
              <p:cNvSpPr txBox="1"/>
              <p:nvPr/>
            </p:nvSpPr>
            <p:spPr>
              <a:xfrm>
                <a:off x="5385401" y="4774406"/>
                <a:ext cx="7772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+ O3FAs</a:t>
                </a:r>
                <a:endParaRPr lang="en-GB" sz="1200" dirty="0"/>
              </a:p>
            </p:txBody>
          </p:sp>
        </p:grp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1C3B6165-796A-3767-8076-D17140C3D3E6}"/>
              </a:ext>
            </a:extLst>
          </p:cNvPr>
          <p:cNvSpPr txBox="1"/>
          <p:nvPr/>
        </p:nvSpPr>
        <p:spPr>
          <a:xfrm>
            <a:off x="504826" y="9842765"/>
            <a:ext cx="585311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6. Abundance of bacterial genes associated with SCFA metabolism.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ead counts for selected SCFA-metabolizing genes in fermentation reactions from n=6 participants in the absence or presence of 0.01 mg/mL inulin. For each enzyme, the read count at the beginning of the fermentation (baseline) is presented next to data from fermentations without (no O3FAs) and with (+ O3FAs [50 </a:t>
            </a:r>
            <a:r>
              <a:rPr lang="en-US" sz="1200" dirty="0"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/mL]). In each case, the column represents the mean read count and the bars represent the standard deviation for n=6 values. No statistical testing was applied to these exploratory data.</a:t>
            </a:r>
            <a:endParaRPr lang="en-GB" sz="12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0157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7</TotalTime>
  <Words>164</Words>
  <Application>Microsoft Office PowerPoint</Application>
  <PresentationFormat>Widescreen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k Hull</dc:creator>
  <cp:lastModifiedBy>Mark Hull</cp:lastModifiedBy>
  <cp:revision>10</cp:revision>
  <dcterms:created xsi:type="dcterms:W3CDTF">2025-09-17T11:30:13Z</dcterms:created>
  <dcterms:modified xsi:type="dcterms:W3CDTF">2025-10-07T08:12:46Z</dcterms:modified>
</cp:coreProperties>
</file>